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8" autoAdjust="0"/>
    <p:restoredTop sz="94660"/>
  </p:normalViewPr>
  <p:slideViewPr>
    <p:cSldViewPr snapToGrid="0">
      <p:cViewPr>
        <p:scale>
          <a:sx n="106" d="100"/>
          <a:sy n="106" d="100"/>
        </p:scale>
        <p:origin x="1548" y="-21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EW\&#9733;&#12467;&#12523;&#12481;&#12414;&#12392;&#1241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178304375370545E-2"/>
          <c:y val="5.3501699645977299E-2"/>
          <c:w val="0.89029285614229547"/>
          <c:h val="0.85798573185882598"/>
        </c:manualLayout>
      </c:layout>
      <c:lineChart>
        <c:grouping val="standard"/>
        <c:varyColors val="0"/>
        <c:ser>
          <c:idx val="0"/>
          <c:order val="0"/>
          <c:tx>
            <c:strRef>
              <c:f>[★コルチまとめ.xlsx]糞便!$B$22</c:f>
              <c:strCache>
                <c:ptCount val="1"/>
                <c:pt idx="0">
                  <c:v>GF-NW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★コルチまとめ.xlsx]糞便!$C$27:$K$27</c:f>
                <c:numCache>
                  <c:formatCode>General</c:formatCode>
                  <c:ptCount val="9"/>
                  <c:pt idx="0">
                    <c:v>13.316376207836802</c:v>
                  </c:pt>
                  <c:pt idx="1">
                    <c:v>2.1994764388231633</c:v>
                  </c:pt>
                  <c:pt idx="2">
                    <c:v>7.579727482402177</c:v>
                  </c:pt>
                  <c:pt idx="3">
                    <c:v>3.8450157613925477</c:v>
                  </c:pt>
                  <c:pt idx="4">
                    <c:v>8.6601680407384229</c:v>
                  </c:pt>
                  <c:pt idx="5">
                    <c:v>10.01196748402803</c:v>
                  </c:pt>
                  <c:pt idx="6">
                    <c:v>3.2133067272603761</c:v>
                  </c:pt>
                  <c:pt idx="7">
                    <c:v>6.5834934278303709</c:v>
                  </c:pt>
                  <c:pt idx="8">
                    <c:v>5.0949095577213557</c:v>
                  </c:pt>
                </c:numCache>
              </c:numRef>
            </c:plus>
            <c:minus>
              <c:numRef>
                <c:f>[★コルチまとめ.xlsx]糞便!$C$27:$K$27</c:f>
                <c:numCache>
                  <c:formatCode>General</c:formatCode>
                  <c:ptCount val="9"/>
                  <c:pt idx="0">
                    <c:v>13.316376207836802</c:v>
                  </c:pt>
                  <c:pt idx="1">
                    <c:v>2.1994764388231633</c:v>
                  </c:pt>
                  <c:pt idx="2">
                    <c:v>7.579727482402177</c:v>
                  </c:pt>
                  <c:pt idx="3">
                    <c:v>3.8450157613925477</c:v>
                  </c:pt>
                  <c:pt idx="4">
                    <c:v>8.6601680407384229</c:v>
                  </c:pt>
                  <c:pt idx="5">
                    <c:v>10.01196748402803</c:v>
                  </c:pt>
                  <c:pt idx="6">
                    <c:v>3.2133067272603761</c:v>
                  </c:pt>
                  <c:pt idx="7">
                    <c:v>6.5834934278303709</c:v>
                  </c:pt>
                  <c:pt idx="8">
                    <c:v>5.09490955772135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[★コルチまとめ.xlsx]糞便!$C$21:$K$21</c:f>
              <c:numCache>
                <c:formatCode>General</c:formatCode>
                <c:ptCount val="9"/>
                <c:pt idx="0">
                  <c:v>4</c:v>
                </c:pt>
                <c:pt idx="2">
                  <c:v>5</c:v>
                </c:pt>
                <c:pt idx="4">
                  <c:v>6</c:v>
                </c:pt>
                <c:pt idx="6">
                  <c:v>7</c:v>
                </c:pt>
                <c:pt idx="8">
                  <c:v>8</c:v>
                </c:pt>
              </c:numCache>
            </c:numRef>
          </c:cat>
          <c:val>
            <c:numRef>
              <c:f>[★コルチまとめ.xlsx]糞便!$C$22:$K$22</c:f>
              <c:numCache>
                <c:formatCode>General</c:formatCode>
                <c:ptCount val="9"/>
                <c:pt idx="0">
                  <c:v>81.404444444444437</c:v>
                </c:pt>
                <c:pt idx="1">
                  <c:v>42.202222222222225</c:v>
                </c:pt>
                <c:pt idx="2">
                  <c:v>47.558571428571433</c:v>
                </c:pt>
                <c:pt idx="3">
                  <c:v>35.583750000000002</c:v>
                </c:pt>
                <c:pt idx="4">
                  <c:v>60.462222222222216</c:v>
                </c:pt>
                <c:pt idx="5">
                  <c:v>48.471111111111114</c:v>
                </c:pt>
                <c:pt idx="6">
                  <c:v>26.188888888888886</c:v>
                </c:pt>
                <c:pt idx="7">
                  <c:v>36.68</c:v>
                </c:pt>
                <c:pt idx="8">
                  <c:v>45.82285714285715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AEA-4B97-ACA4-D8A61FC545DC}"/>
            </c:ext>
          </c:extLst>
        </c:ser>
        <c:ser>
          <c:idx val="1"/>
          <c:order val="1"/>
          <c:tx>
            <c:strRef>
              <c:f>[★コルチまとめ.xlsx]糞便!$B$23</c:f>
              <c:strCache>
                <c:ptCount val="1"/>
                <c:pt idx="0">
                  <c:v>GF-EW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★コルチまとめ.xlsx]糞便!$C$28:$K$28</c:f>
                <c:numCache>
                  <c:formatCode>General</c:formatCode>
                  <c:ptCount val="9"/>
                  <c:pt idx="0">
                    <c:v>12.087414230420736</c:v>
                  </c:pt>
                  <c:pt idx="1">
                    <c:v>14.542712764743138</c:v>
                  </c:pt>
                  <c:pt idx="2">
                    <c:v>10.41667707210364</c:v>
                  </c:pt>
                  <c:pt idx="3">
                    <c:v>4.6905481019384663</c:v>
                  </c:pt>
                  <c:pt idx="4">
                    <c:v>5.4113842583794414</c:v>
                  </c:pt>
                  <c:pt idx="5">
                    <c:v>7.5124661023378652</c:v>
                  </c:pt>
                  <c:pt idx="6">
                    <c:v>5.2939452644115121</c:v>
                  </c:pt>
                  <c:pt idx="7">
                    <c:v>5.3524640224023132</c:v>
                  </c:pt>
                  <c:pt idx="8">
                    <c:v>10.752896024637579</c:v>
                  </c:pt>
                </c:numCache>
              </c:numRef>
            </c:plus>
            <c:minus>
              <c:numRef>
                <c:f>[★コルチまとめ.xlsx]糞便!$C$28:$K$28</c:f>
                <c:numCache>
                  <c:formatCode>General</c:formatCode>
                  <c:ptCount val="9"/>
                  <c:pt idx="0">
                    <c:v>12.087414230420736</c:v>
                  </c:pt>
                  <c:pt idx="1">
                    <c:v>14.542712764743138</c:v>
                  </c:pt>
                  <c:pt idx="2">
                    <c:v>10.41667707210364</c:v>
                  </c:pt>
                  <c:pt idx="3">
                    <c:v>4.6905481019384663</c:v>
                  </c:pt>
                  <c:pt idx="4">
                    <c:v>5.4113842583794414</c:v>
                  </c:pt>
                  <c:pt idx="5">
                    <c:v>7.5124661023378652</c:v>
                  </c:pt>
                  <c:pt idx="6">
                    <c:v>5.2939452644115121</c:v>
                  </c:pt>
                  <c:pt idx="7">
                    <c:v>5.3524640224023132</c:v>
                  </c:pt>
                  <c:pt idx="8">
                    <c:v>10.752896024637579</c:v>
                  </c:pt>
                </c:numCache>
              </c:numRef>
            </c:minus>
            <c:spPr>
              <a:noFill/>
              <a:ln w="952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[★コルチまとめ.xlsx]糞便!$C$21:$K$21</c:f>
              <c:numCache>
                <c:formatCode>General</c:formatCode>
                <c:ptCount val="9"/>
                <c:pt idx="0">
                  <c:v>4</c:v>
                </c:pt>
                <c:pt idx="2">
                  <c:v>5</c:v>
                </c:pt>
                <c:pt idx="4">
                  <c:v>6</c:v>
                </c:pt>
                <c:pt idx="6">
                  <c:v>7</c:v>
                </c:pt>
                <c:pt idx="8">
                  <c:v>8</c:v>
                </c:pt>
              </c:numCache>
            </c:numRef>
          </c:cat>
          <c:val>
            <c:numRef>
              <c:f>[★コルチまとめ.xlsx]糞便!$C$23:$K$23</c:f>
              <c:numCache>
                <c:formatCode>General</c:formatCode>
                <c:ptCount val="9"/>
                <c:pt idx="0">
                  <c:v>89.028333333333322</c:v>
                </c:pt>
                <c:pt idx="1">
                  <c:v>71.175714285714292</c:v>
                </c:pt>
                <c:pt idx="2">
                  <c:v>49.094285714285718</c:v>
                </c:pt>
                <c:pt idx="3">
                  <c:v>39.14714285714286</c:v>
                </c:pt>
                <c:pt idx="4">
                  <c:v>39.592857142857142</c:v>
                </c:pt>
                <c:pt idx="5">
                  <c:v>42.224285714285713</c:v>
                </c:pt>
                <c:pt idx="6">
                  <c:v>32.325714285714284</c:v>
                </c:pt>
                <c:pt idx="7">
                  <c:v>25.723333333333329</c:v>
                </c:pt>
                <c:pt idx="8">
                  <c:v>38.99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AEA-4B97-ACA4-D8A61FC545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96529688"/>
        <c:axId val="496533608"/>
        <c:extLst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[★コルチまとめ.xlsx]糞便!$B$24</c15:sqref>
                        </c15:formulaRef>
                      </c:ext>
                    </c:extLst>
                    <c:strCache>
                      <c:ptCount val="1"/>
                      <c:pt idx="0">
                        <c:v>GF</c:v>
                      </c:pt>
                    </c:strCache>
                  </c:strRef>
                </c:tx>
                <c:spPr>
                  <a:ln w="28575" cap="rnd">
                    <a:solidFill>
                      <a:schemeClr val="tx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tx1"/>
                    </a:solidFill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[★コルチまとめ.xlsx]糞便!$C$29:$K$29</c15:sqref>
                          </c15:formulaRef>
                        </c:ext>
                      </c:extLst>
                      <c:numCache>
                        <c:formatCode>General</c:formatCode>
                        <c:ptCount val="9"/>
                        <c:pt idx="0">
                          <c:v>55.879999999999995</c:v>
                        </c:pt>
                        <c:pt idx="1">
                          <c:v>3.6900000000000022</c:v>
                        </c:pt>
                        <c:pt idx="2">
                          <c:v>0</c:v>
                        </c:pt>
                        <c:pt idx="3">
                          <c:v>26.854999999999997</c:v>
                        </c:pt>
                        <c:pt idx="4">
                          <c:v>32.354999999999997</c:v>
                        </c:pt>
                        <c:pt idx="5">
                          <c:v>23.715000000000011</c:v>
                        </c:pt>
                        <c:pt idx="6">
                          <c:v>7.5300000000000029</c:v>
                        </c:pt>
                        <c:pt idx="7">
                          <c:v>0.96999999999999975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[★コルチまとめ.xlsx]糞便!$C$29:$K$29</c15:sqref>
                          </c15:formulaRef>
                        </c:ext>
                      </c:extLst>
                      <c:numCache>
                        <c:formatCode>General</c:formatCode>
                        <c:ptCount val="9"/>
                        <c:pt idx="0">
                          <c:v>55.879999999999995</c:v>
                        </c:pt>
                        <c:pt idx="1">
                          <c:v>3.6900000000000022</c:v>
                        </c:pt>
                        <c:pt idx="2">
                          <c:v>0</c:v>
                        </c:pt>
                        <c:pt idx="3">
                          <c:v>26.854999999999997</c:v>
                        </c:pt>
                        <c:pt idx="4">
                          <c:v>32.354999999999997</c:v>
                        </c:pt>
                        <c:pt idx="5">
                          <c:v>23.715000000000011</c:v>
                        </c:pt>
                        <c:pt idx="6">
                          <c:v>7.5300000000000029</c:v>
                        </c:pt>
                        <c:pt idx="7">
                          <c:v>0.96999999999999975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>
                      <c:ext uri="{02D57815-91ED-43cb-92C2-25804820EDAC}">
                        <c15:formulaRef>
                          <c15:sqref>[★コルチまとめ.xlsx]糞便!$C$21:$K$21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4</c:v>
                      </c:pt>
                      <c:pt idx="2">
                        <c:v>5</c:v>
                      </c:pt>
                      <c:pt idx="4">
                        <c:v>6</c:v>
                      </c:pt>
                      <c:pt idx="6">
                        <c:v>7</c:v>
                      </c:pt>
                      <c:pt idx="8">
                        <c:v>8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[★コルチまとめ.xlsx]糞便!$C$24:$K$24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67.819999999999993</c:v>
                      </c:pt>
                      <c:pt idx="1">
                        <c:v>18.03</c:v>
                      </c:pt>
                      <c:pt idx="2">
                        <c:v>75.27</c:v>
                      </c:pt>
                      <c:pt idx="3">
                        <c:v>128.22499999999999</c:v>
                      </c:pt>
                      <c:pt idx="4">
                        <c:v>50.274999999999999</c:v>
                      </c:pt>
                      <c:pt idx="5">
                        <c:v>69.545000000000002</c:v>
                      </c:pt>
                      <c:pt idx="6">
                        <c:v>22.919999999999998</c:v>
                      </c:pt>
                      <c:pt idx="7">
                        <c:v>14.190000000000001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2-4AEA-4B97-ACA4-D8A61FC545DC}"/>
                  </c:ext>
                </c:extLst>
              </c15:ser>
            </c15:filteredLineSeries>
          </c:ext>
        </c:extLst>
      </c:lineChart>
      <c:catAx>
        <c:axId val="496529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496533608"/>
        <c:crosses val="autoZero"/>
        <c:auto val="1"/>
        <c:lblAlgn val="ctr"/>
        <c:lblOffset val="100"/>
        <c:noMultiLvlLbl val="0"/>
      </c:catAx>
      <c:valAx>
        <c:axId val="4965336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49652968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3413158847211946"/>
          <c:y val="3.5302696301833881E-3"/>
          <c:w val="0.2658684115278806"/>
          <c:h val="0.2323880405198144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459F9-1FFF-4305-9F18-F90597B2B8CF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21CB6-9CCD-47CA-8682-07DF63D5F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9369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459F9-1FFF-4305-9F18-F90597B2B8CF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21CB6-9CCD-47CA-8682-07DF63D5F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9376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459F9-1FFF-4305-9F18-F90597B2B8CF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21CB6-9CCD-47CA-8682-07DF63D5F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375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459F9-1FFF-4305-9F18-F90597B2B8CF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21CB6-9CCD-47CA-8682-07DF63D5F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822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459F9-1FFF-4305-9F18-F90597B2B8CF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21CB6-9CCD-47CA-8682-07DF63D5F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9749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459F9-1FFF-4305-9F18-F90597B2B8CF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21CB6-9CCD-47CA-8682-07DF63D5F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1217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459F9-1FFF-4305-9F18-F90597B2B8CF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21CB6-9CCD-47CA-8682-07DF63D5F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855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459F9-1FFF-4305-9F18-F90597B2B8CF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21CB6-9CCD-47CA-8682-07DF63D5F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31598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459F9-1FFF-4305-9F18-F90597B2B8CF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21CB6-9CCD-47CA-8682-07DF63D5F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6819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459F9-1FFF-4305-9F18-F90597B2B8CF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21CB6-9CCD-47CA-8682-07DF63D5F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85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C459F9-1FFF-4305-9F18-F90597B2B8CF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21CB6-9CCD-47CA-8682-07DF63D5F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8840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0C459F9-1FFF-4305-9F18-F90597B2B8CF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D121CB6-9CCD-47CA-8682-07DF63D5F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46206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E46E038C-3590-F099-D444-1DFB759B65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2437" y="935684"/>
            <a:ext cx="1857464" cy="23328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7651FDF-9EA1-6D77-CD61-DF26DDF6D34E}"/>
              </a:ext>
            </a:extLst>
          </p:cNvPr>
          <p:cNvSpPr txBox="1"/>
          <p:nvPr/>
        </p:nvSpPr>
        <p:spPr>
          <a:xfrm>
            <a:off x="388336" y="486672"/>
            <a:ext cx="8898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(A)</a:t>
            </a:r>
            <a:endParaRPr lang="ja-JP" altLang="en-US" dirty="0"/>
          </a:p>
          <a:p>
            <a:endParaRPr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4411620-0AB0-26F0-B20A-C5DB668734AF}"/>
              </a:ext>
            </a:extLst>
          </p:cNvPr>
          <p:cNvSpPr txBox="1"/>
          <p:nvPr/>
        </p:nvSpPr>
        <p:spPr>
          <a:xfrm>
            <a:off x="3185321" y="486672"/>
            <a:ext cx="8898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(B)</a:t>
            </a:r>
            <a:endParaRPr lang="ja-JP" altLang="en-US" dirty="0"/>
          </a:p>
          <a:p>
            <a:endParaRPr lang="ja-JP" alt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6E8DC6D-7562-CEC0-2B23-7609E1D544D5}"/>
              </a:ext>
            </a:extLst>
          </p:cNvPr>
          <p:cNvSpPr txBox="1"/>
          <p:nvPr/>
        </p:nvSpPr>
        <p:spPr>
          <a:xfrm rot="16200000">
            <a:off x="2453974" y="1848936"/>
            <a:ext cx="2054352" cy="3091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/>
              <a:t>Distance moved (cm)</a:t>
            </a:r>
            <a:endParaRPr lang="ja-JP" altLang="en-US" sz="14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D223917-087A-F7B3-B40A-51DDA410A108}"/>
              </a:ext>
            </a:extLst>
          </p:cNvPr>
          <p:cNvSpPr txBox="1"/>
          <p:nvPr/>
        </p:nvSpPr>
        <p:spPr>
          <a:xfrm>
            <a:off x="388336" y="3602630"/>
            <a:ext cx="8898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(C)</a:t>
            </a:r>
            <a:endParaRPr lang="ja-JP" altLang="en-US" dirty="0"/>
          </a:p>
          <a:p>
            <a:endParaRPr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A1D417E-7AA2-B78F-FC63-1C93778FC4C8}"/>
              </a:ext>
            </a:extLst>
          </p:cNvPr>
          <p:cNvSpPr txBox="1"/>
          <p:nvPr/>
        </p:nvSpPr>
        <p:spPr>
          <a:xfrm>
            <a:off x="3185321" y="3602630"/>
            <a:ext cx="8898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(D)</a:t>
            </a:r>
            <a:endParaRPr lang="ja-JP" altLang="en-US" dirty="0"/>
          </a:p>
          <a:p>
            <a:endParaRPr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53257E3-7E01-1DE0-2890-B7A1F08EC135}"/>
              </a:ext>
            </a:extLst>
          </p:cNvPr>
          <p:cNvSpPr txBox="1"/>
          <p:nvPr/>
        </p:nvSpPr>
        <p:spPr>
          <a:xfrm rot="16200000">
            <a:off x="2373467" y="4962704"/>
            <a:ext cx="2215366" cy="3091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/>
              <a:t>Distance moved (cm)</a:t>
            </a:r>
            <a:endParaRPr lang="ja-JP" altLang="en-US" sz="14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463BA8E-AB4F-D8A4-996C-9952D47738DF}"/>
              </a:ext>
            </a:extLst>
          </p:cNvPr>
          <p:cNvSpPr txBox="1"/>
          <p:nvPr/>
        </p:nvSpPr>
        <p:spPr>
          <a:xfrm rot="16200000">
            <a:off x="-394096" y="4771867"/>
            <a:ext cx="221536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/>
              <a:t>Time spent in central (sec)</a:t>
            </a:r>
            <a:endParaRPr lang="ja-JP" altLang="en-US" sz="14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305162B-A95F-35B5-6DEC-E78044A95E5D}"/>
              </a:ext>
            </a:extLst>
          </p:cNvPr>
          <p:cNvSpPr txBox="1"/>
          <p:nvPr/>
        </p:nvSpPr>
        <p:spPr>
          <a:xfrm rot="16200000">
            <a:off x="-394096" y="1781758"/>
            <a:ext cx="221536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/>
              <a:t>Time spent in central (sec)</a:t>
            </a:r>
            <a:endParaRPr lang="ja-JP" altLang="en-US" sz="14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59088D4-60E0-A42E-D114-2DFC2831747B}"/>
              </a:ext>
            </a:extLst>
          </p:cNvPr>
          <p:cNvSpPr txBox="1"/>
          <p:nvPr/>
        </p:nvSpPr>
        <p:spPr>
          <a:xfrm>
            <a:off x="5770657" y="925205"/>
            <a:ext cx="14097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200" dirty="0">
                <a:ln>
                  <a:solidFill>
                    <a:schemeClr val="tx1"/>
                  </a:solidFill>
                </a:ln>
              </a:rPr>
              <a:t>■</a:t>
            </a:r>
            <a:r>
              <a:rPr lang="ja-JP" altLang="en-US" sz="1200" dirty="0"/>
              <a:t> </a:t>
            </a:r>
            <a:r>
              <a:rPr lang="en-US" altLang="ja-JP" sz="1200" dirty="0"/>
              <a:t>NW</a:t>
            </a:r>
          </a:p>
          <a:p>
            <a:r>
              <a:rPr lang="ja-JP" altLang="en-US" sz="1200" dirty="0">
                <a:ln>
                  <a:solidFill>
                    <a:schemeClr val="tx1"/>
                  </a:solidFill>
                </a:ln>
                <a:solidFill>
                  <a:srgbClr val="FF0000"/>
                </a:solidFill>
              </a:rPr>
              <a:t>■</a:t>
            </a:r>
            <a:r>
              <a:rPr lang="ja-JP" altLang="en-US" sz="1200" dirty="0"/>
              <a:t> </a:t>
            </a:r>
            <a:r>
              <a:rPr lang="en-US" altLang="ja-JP" sz="1200" dirty="0"/>
              <a:t>EW</a:t>
            </a:r>
          </a:p>
          <a:p>
            <a:endParaRPr lang="en-US" altLang="ja-JP" sz="1200" dirty="0"/>
          </a:p>
          <a:p>
            <a:endParaRPr lang="ja-JP" altLang="en-US" sz="12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7FD67A6-1257-91F4-DC96-253FA59664E0}"/>
              </a:ext>
            </a:extLst>
          </p:cNvPr>
          <p:cNvSpPr txBox="1"/>
          <p:nvPr/>
        </p:nvSpPr>
        <p:spPr>
          <a:xfrm>
            <a:off x="5770657" y="3918651"/>
            <a:ext cx="14097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200" dirty="0">
                <a:ln>
                  <a:solidFill>
                    <a:schemeClr val="tx1"/>
                  </a:solidFill>
                </a:ln>
              </a:rPr>
              <a:t>■</a:t>
            </a:r>
            <a:r>
              <a:rPr lang="ja-JP" altLang="en-US" sz="1200" dirty="0"/>
              <a:t> </a:t>
            </a:r>
            <a:r>
              <a:rPr lang="en-US" altLang="ja-JP" sz="1200" dirty="0"/>
              <a:t>GF-NW</a:t>
            </a:r>
          </a:p>
          <a:p>
            <a:r>
              <a:rPr lang="ja-JP" altLang="en-US" sz="1200" dirty="0">
                <a:ln>
                  <a:solidFill>
                    <a:schemeClr val="tx1"/>
                  </a:solidFill>
                </a:ln>
                <a:solidFill>
                  <a:srgbClr val="FF0000"/>
                </a:solidFill>
              </a:rPr>
              <a:t>■</a:t>
            </a:r>
            <a:r>
              <a:rPr lang="ja-JP" altLang="en-US" sz="1200" dirty="0"/>
              <a:t> </a:t>
            </a:r>
            <a:r>
              <a:rPr lang="en-US" altLang="ja-JP" sz="1200" dirty="0"/>
              <a:t>GF-EW</a:t>
            </a:r>
          </a:p>
          <a:p>
            <a:r>
              <a:rPr lang="ja-JP" altLang="en-US" sz="1200" dirty="0">
                <a:ln>
                  <a:solidFill>
                    <a:schemeClr val="tx1"/>
                  </a:solidFill>
                </a:ln>
                <a:solidFill>
                  <a:schemeClr val="bg1"/>
                </a:solidFill>
              </a:rPr>
              <a:t>■</a:t>
            </a:r>
            <a:r>
              <a:rPr lang="ja-JP" altLang="en-US" sz="1200" dirty="0"/>
              <a:t> </a:t>
            </a:r>
            <a:r>
              <a:rPr lang="en-US" altLang="ja-JP" sz="1200" dirty="0"/>
              <a:t>GF</a:t>
            </a:r>
          </a:p>
          <a:p>
            <a:endParaRPr lang="en-US" altLang="ja-JP" sz="1200" dirty="0"/>
          </a:p>
          <a:p>
            <a:endParaRPr lang="ja-JP" altLang="en-US" sz="1200" dirty="0"/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E2E99B0F-CA89-D65B-ECB9-30FD7589C0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2052" y="935684"/>
            <a:ext cx="1853366" cy="2332244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B8F81661-3A6F-E04E-671C-B5EA76130F6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72053" y="3950867"/>
            <a:ext cx="2022921" cy="23328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D077740D-D432-803E-8A81-EF1B922B95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22437" y="3950867"/>
            <a:ext cx="2019906" cy="233280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4843D0D4-E8E1-AA2A-EF36-573F3ACADB3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72053" y="3950867"/>
            <a:ext cx="2022921" cy="23328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A41BBEE9-B88D-5DD3-967A-F3F62DA0B21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22437" y="3950867"/>
            <a:ext cx="2019906" cy="2332800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44BEA65-7C8C-82A7-47A5-8411A10B9110}"/>
              </a:ext>
            </a:extLst>
          </p:cNvPr>
          <p:cNvSpPr txBox="1"/>
          <p:nvPr/>
        </p:nvSpPr>
        <p:spPr>
          <a:xfrm>
            <a:off x="4821647" y="68635"/>
            <a:ext cx="1898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dditional Fig. S1</a:t>
            </a:r>
            <a:endParaRPr kumimoji="1" lang="ja-JP" altLang="en-US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15EF48F-18DA-C1CB-0C60-682D9F7B21B7}"/>
              </a:ext>
            </a:extLst>
          </p:cNvPr>
          <p:cNvSpPr txBox="1"/>
          <p:nvPr/>
        </p:nvSpPr>
        <p:spPr>
          <a:xfrm>
            <a:off x="258116" y="6631904"/>
            <a:ext cx="6446067" cy="24159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. S1. Comparison between EW and NW, GF-EW and GF-NW mice in open field tests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graph shows the duration spent in the central area (A, C) and the distance traveled (B, D) during the open-field test. In Experiment 1, the time spent in the central area and the distance traveled by the EW mice did not differ from those of the NW mice </a:t>
            </a:r>
            <a:r>
              <a:rPr lang="en-US" altLang="ja-JP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: F(3,56)=2.43, p=0.74; B: F(3,56)=0.713, p=0.56)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</a:t>
            </a:r>
            <a:r>
              <a:rPr lang="en-US" altLang="ja-JP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re was difference found in time spent in center (C: F5.28 = 10.5, p&lt;0.01), and post-hoc revealed the group difference between GF and GF-EW at the age of 4 weeks, but not in GF-EW and GF-NW at both ages. There was difference found in Distance moved (D: F5,28 = 10.5, p&lt;0.01), and post-hoc teste revealed GF and GF-EW (p&lt;0.01), and GF and GF-NW( p&lt;0.01), but not between GF-EW and GF-NW at both age. NW is black, EW is red, and GF is white. Data are presented as mean ± </a:t>
            </a:r>
            <a:r>
              <a:rPr lang="en-US" altLang="ja-JP" sz="1200" kern="100" dirty="0" err="1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.e.m.</a:t>
            </a:r>
            <a:r>
              <a:rPr lang="en-US" altLang="ja-JP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omparison between groups; * P &lt; 0.05, ** P &lt; 0.01.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FE7F1F15-7927-15D3-82F5-1CC5A7A0B5C9}"/>
              </a:ext>
            </a:extLst>
          </p:cNvPr>
          <p:cNvGrpSpPr/>
          <p:nvPr/>
        </p:nvGrpSpPr>
        <p:grpSpPr>
          <a:xfrm>
            <a:off x="1422221" y="4243464"/>
            <a:ext cx="391762" cy="298758"/>
            <a:chOff x="1682439" y="3918651"/>
            <a:chExt cx="399858" cy="298758"/>
          </a:xfrm>
        </p:grpSpPr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C4E56FB5-E1E0-31A8-D60D-70DB87B3A62D}"/>
                </a:ext>
              </a:extLst>
            </p:cNvPr>
            <p:cNvSpPr/>
            <p:nvPr/>
          </p:nvSpPr>
          <p:spPr>
            <a:xfrm>
              <a:off x="1683945" y="3918651"/>
              <a:ext cx="398352" cy="2006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4EC85E0D-DA0A-EEFE-E232-3E96F075F1CC}"/>
                </a:ext>
              </a:extLst>
            </p:cNvPr>
            <p:cNvSpPr/>
            <p:nvPr/>
          </p:nvSpPr>
          <p:spPr>
            <a:xfrm>
              <a:off x="1682439" y="4016733"/>
              <a:ext cx="398352" cy="2006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6F2EA36-00B6-48AD-AAC0-72C8DCE2D47D}"/>
              </a:ext>
            </a:extLst>
          </p:cNvPr>
          <p:cNvSpPr txBox="1"/>
          <p:nvPr/>
        </p:nvSpPr>
        <p:spPr>
          <a:xfrm>
            <a:off x="1459873" y="4034259"/>
            <a:ext cx="313508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5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endParaRPr lang="ja-JP" altLang="en-US" sz="1500" dirty="0"/>
          </a:p>
        </p:txBody>
      </p: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347278B3-17F4-8292-1C84-D5AFD0D91DCB}"/>
              </a:ext>
            </a:extLst>
          </p:cNvPr>
          <p:cNvGrpSpPr/>
          <p:nvPr/>
        </p:nvGrpSpPr>
        <p:grpSpPr>
          <a:xfrm>
            <a:off x="4145806" y="4227447"/>
            <a:ext cx="391762" cy="298758"/>
            <a:chOff x="1682439" y="3918651"/>
            <a:chExt cx="399858" cy="298758"/>
          </a:xfrm>
        </p:grpSpPr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0F17163B-4670-5D3F-BDE2-3D5458DF1882}"/>
                </a:ext>
              </a:extLst>
            </p:cNvPr>
            <p:cNvSpPr/>
            <p:nvPr/>
          </p:nvSpPr>
          <p:spPr>
            <a:xfrm>
              <a:off x="1683945" y="3918651"/>
              <a:ext cx="398352" cy="2006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CEDD4590-1B1E-C9AD-0F06-67A255366739}"/>
                </a:ext>
              </a:extLst>
            </p:cNvPr>
            <p:cNvSpPr/>
            <p:nvPr/>
          </p:nvSpPr>
          <p:spPr>
            <a:xfrm>
              <a:off x="1682439" y="4016733"/>
              <a:ext cx="398352" cy="2006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C9619F0-3196-5222-F1F5-A5FABF667FA5}"/>
              </a:ext>
            </a:extLst>
          </p:cNvPr>
          <p:cNvSpPr txBox="1"/>
          <p:nvPr/>
        </p:nvSpPr>
        <p:spPr>
          <a:xfrm>
            <a:off x="4142892" y="4018242"/>
            <a:ext cx="390286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5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 </a:t>
            </a:r>
            <a:endParaRPr lang="ja-JP" altLang="en-US" sz="1500" dirty="0"/>
          </a:p>
        </p:txBody>
      </p: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170DA3FF-6E8D-8FD3-D28F-4C8C1DBAA9A8}"/>
              </a:ext>
            </a:extLst>
          </p:cNvPr>
          <p:cNvGrpSpPr/>
          <p:nvPr/>
        </p:nvGrpSpPr>
        <p:grpSpPr>
          <a:xfrm>
            <a:off x="4074262" y="4408010"/>
            <a:ext cx="390286" cy="399494"/>
            <a:chOff x="6210880" y="5530638"/>
            <a:chExt cx="390286" cy="399494"/>
          </a:xfrm>
        </p:grpSpPr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D3AE998D-3B4F-C2A4-4199-A69954BE4566}"/>
                </a:ext>
              </a:extLst>
            </p:cNvPr>
            <p:cNvSpPr/>
            <p:nvPr/>
          </p:nvSpPr>
          <p:spPr>
            <a:xfrm>
              <a:off x="6270529" y="5765668"/>
              <a:ext cx="258229" cy="1025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FF083F84-3D0F-5C51-28BC-A34DE419E724}"/>
                </a:ext>
              </a:extLst>
            </p:cNvPr>
            <p:cNvSpPr/>
            <p:nvPr/>
          </p:nvSpPr>
          <p:spPr>
            <a:xfrm>
              <a:off x="6269806" y="5827538"/>
              <a:ext cx="258952" cy="1025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CCAA241D-2B63-E527-3F79-911726B38E5C}"/>
                </a:ext>
              </a:extLst>
            </p:cNvPr>
            <p:cNvSpPr txBox="1"/>
            <p:nvPr/>
          </p:nvSpPr>
          <p:spPr>
            <a:xfrm>
              <a:off x="6210880" y="5530638"/>
              <a:ext cx="390286" cy="3231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500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** </a:t>
              </a:r>
              <a:endParaRPr lang="ja-JP" altLang="en-US" sz="1500" dirty="0"/>
            </a:p>
          </p:txBody>
        </p:sp>
      </p:grpSp>
    </p:spTree>
    <p:extLst>
      <p:ext uri="{BB962C8B-B14F-4D97-AF65-F5344CB8AC3E}">
        <p14:creationId xmlns:p14="http://schemas.microsoft.com/office/powerpoint/2010/main" val="3104271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506EDACE-A198-FF34-5E71-DC7C9F5C4C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8846536"/>
              </p:ext>
            </p:extLst>
          </p:nvPr>
        </p:nvGraphicFramePr>
        <p:xfrm>
          <a:off x="1104314" y="1440570"/>
          <a:ext cx="5328138" cy="34889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AA6979B-E7F0-F323-767C-8516AEF112F6}"/>
              </a:ext>
            </a:extLst>
          </p:cNvPr>
          <p:cNvSpPr txBox="1"/>
          <p:nvPr/>
        </p:nvSpPr>
        <p:spPr>
          <a:xfrm rot="16200000">
            <a:off x="-1015383" y="2783749"/>
            <a:ext cx="34955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/>
              <a:t>Corticosterone (ng/g)</a:t>
            </a:r>
            <a:endParaRPr lang="ja-JP" altLang="en-US" sz="24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2353542-774D-361C-51AF-A5FD268CEBE4}"/>
              </a:ext>
            </a:extLst>
          </p:cNvPr>
          <p:cNvSpPr txBox="1"/>
          <p:nvPr/>
        </p:nvSpPr>
        <p:spPr>
          <a:xfrm>
            <a:off x="1729927" y="4845972"/>
            <a:ext cx="44794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/>
              <a:t>Time (week)</a:t>
            </a:r>
            <a:endParaRPr lang="ja-JP" altLang="en-US" sz="24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AB7A8AD-AB68-7F58-1B8E-69C2AD9649CC}"/>
              </a:ext>
            </a:extLst>
          </p:cNvPr>
          <p:cNvSpPr txBox="1"/>
          <p:nvPr/>
        </p:nvSpPr>
        <p:spPr>
          <a:xfrm>
            <a:off x="4821647" y="68635"/>
            <a:ext cx="1898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dditional Fig. S2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9FFC2FC-ADE9-C832-7B2C-57B214E102F4}"/>
              </a:ext>
            </a:extLst>
          </p:cNvPr>
          <p:cNvSpPr txBox="1"/>
          <p:nvPr/>
        </p:nvSpPr>
        <p:spPr>
          <a:xfrm>
            <a:off x="273600" y="5844252"/>
            <a:ext cx="6446067" cy="11417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ja-JP" sz="12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. S2. Chronological changes in fecal corticosterone levels in each group (GF-NW, n = 9, GF-EW, n = 7).</a:t>
            </a:r>
            <a:endParaRPr lang="ja-JP" altLang="ja-JP" sz="1200" kern="100" dirty="0">
              <a:solidFill>
                <a:srgbClr val="FF0000"/>
              </a:solidFill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US" altLang="ja-JP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. S4 shows the change in fecal corticosterone concentration in each group over time (two-way repeated measures ANOVA, week: F7,63 = 7.591, p &lt; 0.001; group: F1,9 = 0.013, p = 0.911; week × group interaction: F1,63 = 1.953, p = 0.076). </a:t>
            </a:r>
            <a:endParaRPr lang="ja-JP" altLang="ja-JP" sz="1200" kern="100" dirty="0">
              <a:solidFill>
                <a:srgbClr val="FF0000"/>
              </a:solidFill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2526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7</TotalTime>
  <Words>385</Words>
  <Application>Microsoft Office PowerPoint</Application>
  <PresentationFormat>レター サイズ 8.5x11 インチ</PresentationFormat>
  <Paragraphs>2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ptos</vt:lpstr>
      <vt:lpstr>Aptos Display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菊水 健史</dc:creator>
  <cp:lastModifiedBy>菊水 健史</cp:lastModifiedBy>
  <cp:revision>13</cp:revision>
  <dcterms:created xsi:type="dcterms:W3CDTF">2024-04-25T02:57:51Z</dcterms:created>
  <dcterms:modified xsi:type="dcterms:W3CDTF">2024-04-26T00:24:20Z</dcterms:modified>
</cp:coreProperties>
</file>